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179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807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905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830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221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279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654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615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40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642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479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7167E-BD92-4021-9BD6-2EC9CFFE833E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54606-FD43-4097-820B-FE4521FA9B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817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1">
            <a:extLst>
              <a:ext uri="{FF2B5EF4-FFF2-40B4-BE49-F238E27FC236}">
                <a16:creationId xmlns:a16="http://schemas.microsoft.com/office/drawing/2014/main" id="{1663EA20-50AE-25C8-8EE3-BAD83A4DA4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4395" y="213824"/>
            <a:ext cx="4983211" cy="4704300"/>
          </a:xfrm>
          <a:prstGeom prst="rect">
            <a:avLst/>
          </a:prstGeom>
        </p:spPr>
      </p:pic>
      <p:sp>
        <p:nvSpPr>
          <p:cNvPr id="5" name="テキスト ボックス 5">
            <a:extLst>
              <a:ext uri="{FF2B5EF4-FFF2-40B4-BE49-F238E27FC236}">
                <a16:creationId xmlns:a16="http://schemas.microsoft.com/office/drawing/2014/main" id="{8C71E091-FE88-DB79-D4C0-6E9D19A7273B}"/>
              </a:ext>
            </a:extLst>
          </p:cNvPr>
          <p:cNvSpPr txBox="1"/>
          <p:nvPr/>
        </p:nvSpPr>
        <p:spPr>
          <a:xfrm>
            <a:off x="7211847" y="2843787"/>
            <a:ext cx="2079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y=0.8174x-0.2559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 7">
            <a:extLst>
              <a:ext uri="{FF2B5EF4-FFF2-40B4-BE49-F238E27FC236}">
                <a16:creationId xmlns:a16="http://schemas.microsoft.com/office/drawing/2014/main" id="{25F3CFCD-51FC-4D37-2D39-A2E839E7AD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6946005"/>
              </p:ext>
            </p:extLst>
          </p:nvPr>
        </p:nvGraphicFramePr>
        <p:xfrm>
          <a:off x="4208364" y="308227"/>
          <a:ext cx="404731" cy="33596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4731">
                  <a:extLst>
                    <a:ext uri="{9D8B030D-6E8A-4147-A177-3AD203B41FA5}">
                      <a16:colId xmlns:a16="http://schemas.microsoft.com/office/drawing/2014/main" val="3465483925"/>
                    </a:ext>
                  </a:extLst>
                </a:gridCol>
              </a:tblGrid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b="1" baseline="3000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6272973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b="1" baseline="3000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7179882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b="1" baseline="3000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8474284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b="1" baseline="3000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5309316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b="1" baseline="3000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1388294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b="1" baseline="30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9637285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b="1" baseline="3000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8404804"/>
                  </a:ext>
                </a:extLst>
              </a:tr>
              <a:tr h="41995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b="1" baseline="30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0037098"/>
                  </a:ext>
                </a:extLst>
              </a:tr>
            </a:tbl>
          </a:graphicData>
        </a:graphic>
      </p:graphicFrame>
      <p:graphicFrame>
        <p:nvGraphicFramePr>
          <p:cNvPr id="7" name="表 9">
            <a:extLst>
              <a:ext uri="{FF2B5EF4-FFF2-40B4-BE49-F238E27FC236}">
                <a16:creationId xmlns:a16="http://schemas.microsoft.com/office/drawing/2014/main" id="{885EDD09-C7D3-C4CF-0550-38556F081C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2470661"/>
              </p:ext>
            </p:extLst>
          </p:nvPr>
        </p:nvGraphicFramePr>
        <p:xfrm>
          <a:off x="4921318" y="3966303"/>
          <a:ext cx="3359656" cy="2769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9957">
                  <a:extLst>
                    <a:ext uri="{9D8B030D-6E8A-4147-A177-3AD203B41FA5}">
                      <a16:colId xmlns:a16="http://schemas.microsoft.com/office/drawing/2014/main" val="2071239456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2564236526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4006236868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3891893862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3817764143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1429250551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1036489544"/>
                    </a:ext>
                  </a:extLst>
                </a:gridCol>
                <a:gridCol w="419957">
                  <a:extLst>
                    <a:ext uri="{9D8B030D-6E8A-4147-A177-3AD203B41FA5}">
                      <a16:colId xmlns:a16="http://schemas.microsoft.com/office/drawing/2014/main" val="2361225281"/>
                    </a:ext>
                  </a:extLst>
                </a:gridCol>
              </a:tblGrid>
              <a:tr h="27692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baseline="30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7985718"/>
                  </a:ext>
                </a:extLst>
              </a:tr>
            </a:tbl>
          </a:graphicData>
        </a:graphic>
      </p:graphicFrame>
      <p:sp>
        <p:nvSpPr>
          <p:cNvPr id="8" name="テキスト ボックス 2">
            <a:extLst>
              <a:ext uri="{FF2B5EF4-FFF2-40B4-BE49-F238E27FC236}">
                <a16:creationId xmlns:a16="http://schemas.microsoft.com/office/drawing/2014/main" id="{E6045974-E1DF-DCDA-D761-8B5BE5D2713C}"/>
              </a:ext>
            </a:extLst>
          </p:cNvPr>
          <p:cNvSpPr txBox="1"/>
          <p:nvPr/>
        </p:nvSpPr>
        <p:spPr>
          <a:xfrm>
            <a:off x="1925655" y="4858107"/>
            <a:ext cx="935098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ditional File</a:t>
            </a: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3.</a:t>
            </a:r>
            <a:r>
              <a:rPr lang="en-GB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The viral load of the paired samples as determined by RT-PCR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GB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The X-axis shows the viral load of the samples stored in virus transport media (VTM) used for RT-PCR and viral culture. The Y axis shows the viral load of the samples used for Lumira Ag testing. The viral load was expressed as copies/test. Y = 0.8174x-0.2559, the </a:t>
            </a:r>
            <a:r>
              <a:rPr lang="en-GB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orrelation coefficient was 0.8136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0447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游明朝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nisRaymund Tag-at</dc:creator>
  <cp:lastModifiedBy>DennisRaymund Tag-at</cp:lastModifiedBy>
  <cp:revision>1</cp:revision>
  <dcterms:created xsi:type="dcterms:W3CDTF">2023-11-15T02:56:09Z</dcterms:created>
  <dcterms:modified xsi:type="dcterms:W3CDTF">2023-11-15T02:56:35Z</dcterms:modified>
</cp:coreProperties>
</file>